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2"/>
    <p:restoredTop sz="94704"/>
  </p:normalViewPr>
  <p:slideViewPr>
    <p:cSldViewPr snapToGrid="0" snapToObjects="1">
      <p:cViewPr>
        <p:scale>
          <a:sx n="109" d="100"/>
          <a:sy n="109" d="100"/>
        </p:scale>
        <p:origin x="1421" y="3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55CC7B-8770-EB40-8AB3-698CDCF73EF3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CB42C1-0406-5149-9D3B-6ECD5DED749E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01215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9CB42C1-0406-5149-9D3B-6ECD5DED749E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64324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3362B-F50B-2946-A749-8ABBC9AF83D5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CB986-7127-B94E-BDE3-A2E67164BEF9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0903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3362B-F50B-2946-A749-8ABBC9AF83D5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CB986-7127-B94E-BDE3-A2E67164BEF9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878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3362B-F50B-2946-A749-8ABBC9AF83D5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CB986-7127-B94E-BDE3-A2E67164BEF9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8960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3362B-F50B-2946-A749-8ABBC9AF83D5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CB986-7127-B94E-BDE3-A2E67164BEF9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1326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3362B-F50B-2946-A749-8ABBC9AF83D5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CB986-7127-B94E-BDE3-A2E67164BEF9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1662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3362B-F50B-2946-A749-8ABBC9AF83D5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CB986-7127-B94E-BDE3-A2E67164BEF9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352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3362B-F50B-2946-A749-8ABBC9AF83D5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CB986-7127-B94E-BDE3-A2E67164BEF9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9175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3362B-F50B-2946-A749-8ABBC9AF83D5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CB986-7127-B94E-BDE3-A2E67164BEF9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48715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3362B-F50B-2946-A749-8ABBC9AF83D5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CB986-7127-B94E-BDE3-A2E67164BEF9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0968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3362B-F50B-2946-A749-8ABBC9AF83D5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CB986-7127-B94E-BDE3-A2E67164BEF9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6515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3362B-F50B-2946-A749-8ABBC9AF83D5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7CB986-7127-B94E-BDE3-A2E67164BEF9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63893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53362B-F50B-2946-A749-8ABBC9AF83D5}" type="datetimeFigureOut">
              <a:rPr lang="fr-FR" smtClean="0"/>
              <a:t>11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7CB986-7127-B94E-BDE3-A2E67164BEF9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632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emf"/><Relationship Id="rId4" Type="http://schemas.openxmlformats.org/officeDocument/2006/relationships/package" Target="../embeddings/Microsoft_Excel_Worksheet.xlsx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64073762-0CD4-C940-BE14-7F4B23ABDB2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615"/>
          <a:stretch/>
        </p:blipFill>
        <p:spPr>
          <a:xfrm>
            <a:off x="1255495" y="211950"/>
            <a:ext cx="4658326" cy="4197444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2" name="Objet 1">
            <a:extLst>
              <a:ext uri="{FF2B5EF4-FFF2-40B4-BE49-F238E27FC236}">
                <a16:creationId xmlns:a16="http://schemas.microsoft.com/office/drawing/2014/main" id="{53900EAA-6C08-4E4B-93F3-5B0EF2E9F49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4421046"/>
              </p:ext>
            </p:extLst>
          </p:nvPr>
        </p:nvGraphicFramePr>
        <p:xfrm>
          <a:off x="3734731" y="310228"/>
          <a:ext cx="1986399" cy="17778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Feuille de calcul" r:id="rId4" imgW="2540000" imgH="2273300" progId="Excel.Sheet.12">
                  <p:embed/>
                </p:oleObj>
              </mc:Choice>
              <mc:Fallback>
                <p:oleObj name="Feuille de calcul" r:id="rId4" imgW="2540000" imgH="22733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734731" y="310228"/>
                        <a:ext cx="1986399" cy="1777827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D47617E2-A41C-AA4C-9624-461D5B1AE1B4}"/>
              </a:ext>
            </a:extLst>
          </p:cNvPr>
          <p:cNvSpPr txBox="1"/>
          <p:nvPr/>
        </p:nvSpPr>
        <p:spPr>
          <a:xfrm>
            <a:off x="714835" y="4409394"/>
            <a:ext cx="555564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7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ercentage of variance explained by each of the dimensions of the Principal Components Analysis (PCA). </a:t>
            </a: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contribution of each environmental variable to the first two PCA dimensions are provided in the table.</a:t>
            </a:r>
          </a:p>
        </p:txBody>
      </p:sp>
    </p:spTree>
    <p:extLst>
      <p:ext uri="{BB962C8B-B14F-4D97-AF65-F5344CB8AC3E}">
        <p14:creationId xmlns:p14="http://schemas.microsoft.com/office/powerpoint/2010/main" val="368558660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1</TotalTime>
  <Words>40</Words>
  <Application>Microsoft Office PowerPoint</Application>
  <PresentationFormat>A4 (210 x 297 mm)</PresentationFormat>
  <Paragraphs>3</Paragraphs>
  <Slides>1</Slides>
  <Notes>1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Feuille de calcul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Julieta Orlando</cp:lastModifiedBy>
  <cp:revision>7</cp:revision>
  <dcterms:created xsi:type="dcterms:W3CDTF">2021-06-08T23:31:23Z</dcterms:created>
  <dcterms:modified xsi:type="dcterms:W3CDTF">2021-06-11T16:54:55Z</dcterms:modified>
</cp:coreProperties>
</file>